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731" y="7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5EB3D0-BA1C-4E74-93B1-D3662FE796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E61C691-C7CC-4A88-BBDF-884FAAE3F9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EF00E9-A2E0-4C44-A5ED-26CB2C16A4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8014B-C178-4DFA-9789-FE2C5E4571FD}" type="datetimeFigureOut">
              <a:rPr lang="zh-CN" altLang="en-US" smtClean="0"/>
              <a:t>2021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5ADF85-8615-47AA-A39F-CD2532A129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AA673CF-BFC5-4590-B00B-DBAC31196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360F1-883A-4DF7-A381-502BDA669D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7878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79B3D4-74EC-4EB3-9330-553E1ADA93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161E9B3-EEEC-4084-BADC-3EF55229A4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A65BCE-0582-4A41-953F-E4001DEB5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8014B-C178-4DFA-9789-FE2C5E4571FD}" type="datetimeFigureOut">
              <a:rPr lang="zh-CN" altLang="en-US" smtClean="0"/>
              <a:t>2021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A45856-AF44-4EED-9DF4-16BCCBB15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6F7A6BB-86D2-43DC-A183-98696F454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360F1-883A-4DF7-A381-502BDA669D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1984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117CBFA-39A7-4D47-ABA0-EFD84F0F22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5C36529-5672-48AE-940D-1CA9D3494A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CE281E-6A53-4CE3-84ED-CE0AAC8DBE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8014B-C178-4DFA-9789-FE2C5E4571FD}" type="datetimeFigureOut">
              <a:rPr lang="zh-CN" altLang="en-US" smtClean="0"/>
              <a:t>2021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8F97C3F-EC6B-4CB4-8464-A812EE20C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3495DD3-E4E9-405F-A82E-8C6CCFAD7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360F1-883A-4DF7-A381-502BDA669D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0270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D3CB1F-DBEC-4526-B995-76DBC40D3E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E5521C-4269-4BC5-9B12-650F2455F3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184CF5-C36B-4183-BAAC-66B05E318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8014B-C178-4DFA-9789-FE2C5E4571FD}" type="datetimeFigureOut">
              <a:rPr lang="zh-CN" altLang="en-US" smtClean="0"/>
              <a:t>2021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6CB7BF-4556-4D1F-9772-217733B2A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95CBAD-018F-4FF1-BB95-A243A27BA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360F1-883A-4DF7-A381-502BDA669D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8490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20DEFB-13A9-47F1-A9EE-D4B538054B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A2D8F05-8301-4F58-AC4C-6196F42D31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75868DF-5D3D-45E6-9793-AAA67DADE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8014B-C178-4DFA-9789-FE2C5E4571FD}" type="datetimeFigureOut">
              <a:rPr lang="zh-CN" altLang="en-US" smtClean="0"/>
              <a:t>2021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CF2B7C-84B7-48C7-937F-A614573A81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429F42-9417-4C12-97FB-1592179D7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360F1-883A-4DF7-A381-502BDA669D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2048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A70B8B-88E4-4260-9835-B872AB8CA9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44E3373-311E-472E-B4E0-2A2145F58C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E1B8979-C3A1-44BF-A4FF-01C694451F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2B0ECF7-F8E7-4477-93C8-07D89BA5D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8014B-C178-4DFA-9789-FE2C5E4571FD}" type="datetimeFigureOut">
              <a:rPr lang="zh-CN" altLang="en-US" smtClean="0"/>
              <a:t>2021/1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B37CF11-693D-4CEF-B599-00CE457DA1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1AE1A4A-DD2C-430D-A5EA-38775D691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360F1-883A-4DF7-A381-502BDA669D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362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20B004-10E7-4224-943C-685060089C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3280CF6-3557-4C86-ABF1-5257236066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0860A58-D55F-4E95-AA75-D6AACC9ED9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D5BC057-1F37-43FA-91F0-425C594FF7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736FC22-9CFA-4563-8F79-8F82BE030E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3C3CA45-2066-48CD-88E1-7475B367C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8014B-C178-4DFA-9789-FE2C5E4571FD}" type="datetimeFigureOut">
              <a:rPr lang="zh-CN" altLang="en-US" smtClean="0"/>
              <a:t>2021/12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E446C72-A79F-4CB8-8271-DD92E3DAB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48C4221-E049-45B9-AC9E-B62FAAFFBC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360F1-883A-4DF7-A381-502BDA669D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4416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181D2E-A182-497A-B299-F46F4421F1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4305A79-1A3D-48E7-8894-3C5E60F061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8014B-C178-4DFA-9789-FE2C5E4571FD}" type="datetimeFigureOut">
              <a:rPr lang="zh-CN" altLang="en-US" smtClean="0"/>
              <a:t>2021/12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10D344E-FEDF-455E-AB11-08980FFD47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411915B-D37A-481C-9136-49F7D9B815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360F1-883A-4DF7-A381-502BDA669D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2051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1293AB8-DFF9-4EE6-B7D6-6CE6E4FE8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8014B-C178-4DFA-9789-FE2C5E4571FD}" type="datetimeFigureOut">
              <a:rPr lang="zh-CN" altLang="en-US" smtClean="0"/>
              <a:t>2021/12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949784F-12A2-4F77-B3BB-E3F7C9B092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C610A01-440E-4758-BC2F-5697E9DE07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360F1-883A-4DF7-A381-502BDA669D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23798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75F08D-930B-4F74-BFE8-BA6A9388BD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B83021A-C6AA-4DBB-A4F0-A2FCBD46D7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E76A118-3051-4965-8822-2C751F00BE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D355F33-09D0-46AE-8DA1-98499E7902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8014B-C178-4DFA-9789-FE2C5E4571FD}" type="datetimeFigureOut">
              <a:rPr lang="zh-CN" altLang="en-US" smtClean="0"/>
              <a:t>2021/1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365DDF4-A958-45A3-ADBF-3D5995013A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03E9C18-2C74-485D-AAA4-9ED07973DA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360F1-883A-4DF7-A381-502BDA669D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072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6C8B83-B545-429F-9074-BBDABF15F5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8BD9C66-B3FF-48BE-AB20-F1BFFB7086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8997962-3A0C-455E-84FC-47D2A49873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940DB4C-8112-4AA9-BA14-31431ECEC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8014B-C178-4DFA-9789-FE2C5E4571FD}" type="datetimeFigureOut">
              <a:rPr lang="zh-CN" altLang="en-US" smtClean="0"/>
              <a:t>2021/1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6406FFE-47E9-4EE8-AFE1-486F0CE7D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D05219D-19CE-4623-B1EE-6FCEEA2DE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360F1-883A-4DF7-A381-502BDA669D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4518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51C389F-F881-456D-8234-23B469309D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0428E92-F40B-4D17-9B66-DED8ADFF3B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EE536E-3441-46B1-B37E-A0FCFED238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18014B-C178-4DFA-9789-FE2C5E4571FD}" type="datetimeFigureOut">
              <a:rPr lang="zh-CN" altLang="en-US" smtClean="0"/>
              <a:t>2021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7652C9-29BD-4797-ABFD-A660C66C87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463DB8B-1E44-40BB-8EF2-14C60983AD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8360F1-883A-4DF7-A381-502BDA669D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1043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4EBCCB0-F689-4A4C-8F70-F2E476E207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0938" y="0"/>
            <a:ext cx="7234220" cy="68580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82D0ACBD-51B7-4168-A2EC-087386FA9D5F}"/>
              </a:ext>
            </a:extLst>
          </p:cNvPr>
          <p:cNvSpPr txBox="1"/>
          <p:nvPr/>
        </p:nvSpPr>
        <p:spPr>
          <a:xfrm>
            <a:off x="405352" y="1734532"/>
            <a:ext cx="2978869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  <a:p>
            <a:pPr algn="l"/>
            <a:r>
              <a:rPr lang="en-US" altLang="zh-CN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erfall diagram of best change in total target lesion size by patient. (a) Different dacomitinib application lines. (b) Single dacomitinib subgroup </a:t>
            </a:r>
            <a:r>
              <a:rPr lang="en-US" altLang="zh-CN" sz="1800" b="0" i="1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.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binatory dacomitinib subgroup. (c) Subgroups with brain metastases and without. (d) Subgroups with different mutation status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27083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55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鸿帅</dc:creator>
  <cp:lastModifiedBy>李鸿帅</cp:lastModifiedBy>
  <cp:revision>5</cp:revision>
  <dcterms:created xsi:type="dcterms:W3CDTF">2021-09-08T14:51:12Z</dcterms:created>
  <dcterms:modified xsi:type="dcterms:W3CDTF">2021-12-13T13:30:02Z</dcterms:modified>
</cp:coreProperties>
</file>